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7" d="100"/>
          <a:sy n="67" d="100"/>
        </p:scale>
        <p:origin x="139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F197B99-A915-42C1-9099-EA7AB11A9939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5F5C867-B357-493D-94D2-A1E29F45B8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79833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5F5C867-B357-493D-94D2-A1E29F45B89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47530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ED894-FCF1-441A-B408-6CA4668C7E6E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7DA07E-34F8-4414-8EBF-43F7BCDC07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36932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ED894-FCF1-441A-B408-6CA4668C7E6E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7DA07E-34F8-4414-8EBF-43F7BCDC07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62901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ED894-FCF1-441A-B408-6CA4668C7E6E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7DA07E-34F8-4414-8EBF-43F7BCDC07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39148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ED894-FCF1-441A-B408-6CA4668C7E6E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7DA07E-34F8-4414-8EBF-43F7BCDC07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40527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ED894-FCF1-441A-B408-6CA4668C7E6E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7DA07E-34F8-4414-8EBF-43F7BCDC07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27075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ED894-FCF1-441A-B408-6CA4668C7E6E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7DA07E-34F8-4414-8EBF-43F7BCDC07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06937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ED894-FCF1-441A-B408-6CA4668C7E6E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7DA07E-34F8-4414-8EBF-43F7BCDC07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42103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ED894-FCF1-441A-B408-6CA4668C7E6E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7DA07E-34F8-4414-8EBF-43F7BCDC07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81879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ED894-FCF1-441A-B408-6CA4668C7E6E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7DA07E-34F8-4414-8EBF-43F7BCDC07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38250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ED894-FCF1-441A-B408-6CA4668C7E6E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7DA07E-34F8-4414-8EBF-43F7BCDC07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28932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ED894-FCF1-441A-B408-6CA4668C7E6E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7DA07E-34F8-4414-8EBF-43F7BCDC07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08827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7ED894-FCF1-441A-B408-6CA4668C7E6E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7DA07E-34F8-4414-8EBF-43F7BCDC07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87680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60059683"/>
              </p:ext>
            </p:extLst>
          </p:nvPr>
        </p:nvGraphicFramePr>
        <p:xfrm>
          <a:off x="420688" y="1209675"/>
          <a:ext cx="8751887" cy="4083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9" name="Prism 7" r:id="rId4" imgW="8838091" imgH="4119442" progId="Prism7.Document">
                  <p:embed/>
                </p:oleObj>
              </mc:Choice>
              <mc:Fallback>
                <p:oleObj name="Prism 7" r:id="rId4" imgW="8838091" imgH="4119442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20688" y="1209675"/>
                        <a:ext cx="8751887" cy="40830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/>
          <p:cNvSpPr txBox="1"/>
          <p:nvPr/>
        </p:nvSpPr>
        <p:spPr>
          <a:xfrm rot="16200000">
            <a:off x="-154035" y="3994487"/>
            <a:ext cx="8181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PKM</a:t>
            </a:r>
          </a:p>
        </p:txBody>
      </p:sp>
      <p:sp>
        <p:nvSpPr>
          <p:cNvPr id="7" name="TextBox 6"/>
          <p:cNvSpPr txBox="1"/>
          <p:nvPr/>
        </p:nvSpPr>
        <p:spPr>
          <a:xfrm rot="16200000">
            <a:off x="-154034" y="1933931"/>
            <a:ext cx="8181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PKM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363269" y="1182102"/>
            <a:ext cx="8181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lock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479411" y="1182102"/>
            <a:ext cx="8181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Per2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5620902" y="1182102"/>
            <a:ext cx="8181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Nr1d1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7638323" y="1182102"/>
            <a:ext cx="8181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Nr1d2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1363269" y="3418851"/>
            <a:ext cx="8181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Nfil3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3479411" y="3400747"/>
            <a:ext cx="8181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rnt1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5620902" y="3418851"/>
            <a:ext cx="8181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ry1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7717117" y="2118597"/>
            <a:ext cx="35186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8614605" y="1452147"/>
            <a:ext cx="3518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$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8467270" y="1452147"/>
            <a:ext cx="3518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1377264" y="3805684"/>
            <a:ext cx="35186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1826154" y="4049276"/>
            <a:ext cx="3518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670154" y="4074497"/>
            <a:ext cx="35186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3421472" y="4218845"/>
            <a:ext cx="35186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3835292" y="4218845"/>
            <a:ext cx="35186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4249112" y="4037247"/>
            <a:ext cx="35186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5619975" y="3721296"/>
            <a:ext cx="35186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6048985" y="3994487"/>
            <a:ext cx="3518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itle 1"/>
          <p:cNvSpPr txBox="1">
            <a:spLocks/>
          </p:cNvSpPr>
          <p:nvPr/>
        </p:nvSpPr>
        <p:spPr>
          <a:xfrm>
            <a:off x="39239" y="55923"/>
            <a:ext cx="2980080" cy="421115"/>
          </a:xfrm>
          <a:prstGeom prst="rect">
            <a:avLst/>
          </a:prstGeom>
        </p:spPr>
        <p:txBody>
          <a:bodyPr vert="horz" lIns="68580" tIns="34291" rIns="68580" bIns="34291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8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941756" y="5287584"/>
            <a:ext cx="15878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ays post-MI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2999326" y="5287584"/>
            <a:ext cx="15878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ays post-MI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5172895" y="5287584"/>
            <a:ext cx="15878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ays post-MI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7288677" y="3041841"/>
            <a:ext cx="15878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ays post-MI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5303443" y="3041841"/>
            <a:ext cx="15878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ays post-MI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3053118" y="3041841"/>
            <a:ext cx="15878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ays post-MI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897858" y="3041841"/>
            <a:ext cx="15878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ays post-MI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8074463" y="1691668"/>
            <a:ext cx="35186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8115407" y="1849052"/>
            <a:ext cx="3518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6474075" y="4111123"/>
            <a:ext cx="3518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2211350" y="3864610"/>
            <a:ext cx="3518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530053" y="2673074"/>
            <a:ext cx="3382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512989" y="2159905"/>
            <a:ext cx="3382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408135" y="1644055"/>
            <a:ext cx="4430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2707319" y="2665832"/>
            <a:ext cx="3343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2690255" y="2084423"/>
            <a:ext cx="3343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2585400" y="1473037"/>
            <a:ext cx="4380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4818441" y="2657569"/>
            <a:ext cx="3382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4696524" y="2084423"/>
            <a:ext cx="4430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4687072" y="1465713"/>
            <a:ext cx="4430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6892105" y="2657569"/>
            <a:ext cx="3382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6770188" y="2084423"/>
            <a:ext cx="4430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6760736" y="1465713"/>
            <a:ext cx="4430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531941" y="4869746"/>
            <a:ext cx="3382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408135" y="4233745"/>
            <a:ext cx="4586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410023" y="3663303"/>
            <a:ext cx="4430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2674863" y="4858115"/>
            <a:ext cx="3382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2674863" y="4452190"/>
            <a:ext cx="3382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2547508" y="4058074"/>
            <a:ext cx="4669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2551696" y="3663303"/>
            <a:ext cx="4669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4805299" y="4853919"/>
            <a:ext cx="3382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4696525" y="4253719"/>
            <a:ext cx="4469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4685112" y="3654091"/>
            <a:ext cx="4469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941756" y="2832321"/>
            <a:ext cx="3382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1380266" y="2832321"/>
            <a:ext cx="3382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67" name="TextBox 66"/>
          <p:cNvSpPr txBox="1"/>
          <p:nvPr/>
        </p:nvSpPr>
        <p:spPr>
          <a:xfrm>
            <a:off x="1802436" y="2832321"/>
            <a:ext cx="3382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2241317" y="2832321"/>
            <a:ext cx="3382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69" name="TextBox 68"/>
          <p:cNvSpPr txBox="1"/>
          <p:nvPr/>
        </p:nvSpPr>
        <p:spPr>
          <a:xfrm>
            <a:off x="3098585" y="2832321"/>
            <a:ext cx="3382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3524125" y="2832321"/>
            <a:ext cx="3382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71" name="TextBox 70"/>
          <p:cNvSpPr txBox="1"/>
          <p:nvPr/>
        </p:nvSpPr>
        <p:spPr>
          <a:xfrm>
            <a:off x="3945617" y="2832321"/>
            <a:ext cx="3382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4370850" y="2832321"/>
            <a:ext cx="3382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73" name="TextBox 72"/>
          <p:cNvSpPr txBox="1"/>
          <p:nvPr/>
        </p:nvSpPr>
        <p:spPr>
          <a:xfrm>
            <a:off x="5203308" y="2832321"/>
            <a:ext cx="3382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5641818" y="2832321"/>
            <a:ext cx="3382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75" name="TextBox 74"/>
          <p:cNvSpPr txBox="1"/>
          <p:nvPr/>
        </p:nvSpPr>
        <p:spPr>
          <a:xfrm>
            <a:off x="6063988" y="2832321"/>
            <a:ext cx="3382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6502869" y="2832321"/>
            <a:ext cx="3382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77" name="TextBox 76"/>
          <p:cNvSpPr txBox="1"/>
          <p:nvPr/>
        </p:nvSpPr>
        <p:spPr>
          <a:xfrm>
            <a:off x="7290833" y="2832321"/>
            <a:ext cx="3382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7688399" y="2832321"/>
            <a:ext cx="3382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79" name="TextBox 78"/>
          <p:cNvSpPr txBox="1"/>
          <p:nvPr/>
        </p:nvSpPr>
        <p:spPr>
          <a:xfrm>
            <a:off x="8110569" y="2832321"/>
            <a:ext cx="3382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8549450" y="2832321"/>
            <a:ext cx="3382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81" name="TextBox 80"/>
          <p:cNvSpPr txBox="1"/>
          <p:nvPr/>
        </p:nvSpPr>
        <p:spPr>
          <a:xfrm>
            <a:off x="946048" y="5040196"/>
            <a:ext cx="3382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1343614" y="5040196"/>
            <a:ext cx="3382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83" name="TextBox 82"/>
          <p:cNvSpPr txBox="1"/>
          <p:nvPr/>
        </p:nvSpPr>
        <p:spPr>
          <a:xfrm>
            <a:off x="1765784" y="5040196"/>
            <a:ext cx="3382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2204665" y="5040196"/>
            <a:ext cx="3382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85" name="TextBox 84"/>
          <p:cNvSpPr txBox="1"/>
          <p:nvPr/>
        </p:nvSpPr>
        <p:spPr>
          <a:xfrm>
            <a:off x="3101808" y="5040196"/>
            <a:ext cx="3382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3499374" y="5040196"/>
            <a:ext cx="3382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87" name="TextBox 86"/>
          <p:cNvSpPr txBox="1"/>
          <p:nvPr/>
        </p:nvSpPr>
        <p:spPr>
          <a:xfrm>
            <a:off x="3921544" y="5040196"/>
            <a:ext cx="3382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4360425" y="5040196"/>
            <a:ext cx="3382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89" name="TextBox 88"/>
          <p:cNvSpPr txBox="1"/>
          <p:nvPr/>
        </p:nvSpPr>
        <p:spPr>
          <a:xfrm>
            <a:off x="5215458" y="5040196"/>
            <a:ext cx="3382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5613024" y="5040196"/>
            <a:ext cx="3382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91" name="TextBox 90"/>
          <p:cNvSpPr txBox="1"/>
          <p:nvPr/>
        </p:nvSpPr>
        <p:spPr>
          <a:xfrm>
            <a:off x="6035194" y="5040196"/>
            <a:ext cx="3382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6474075" y="5040196"/>
            <a:ext cx="3382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93" name="TextBox 92"/>
          <p:cNvSpPr txBox="1"/>
          <p:nvPr/>
        </p:nvSpPr>
        <p:spPr>
          <a:xfrm>
            <a:off x="2056301" y="3868033"/>
            <a:ext cx="35186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2220634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9</TotalTime>
  <Words>92</Words>
  <Application>Microsoft Office PowerPoint</Application>
  <PresentationFormat>On-screen Show (4:3)</PresentationFormat>
  <Paragraphs>83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7</vt:lpstr>
      <vt:lpstr>PowerPoint Presentation</vt:lpstr>
    </vt:vector>
  </TitlesOfParts>
  <Company>UMM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an Mouton</dc:creator>
  <cp:lastModifiedBy>Alan Mouton</cp:lastModifiedBy>
  <cp:revision>14</cp:revision>
  <dcterms:created xsi:type="dcterms:W3CDTF">2018-03-17T15:32:34Z</dcterms:created>
  <dcterms:modified xsi:type="dcterms:W3CDTF">2018-05-09T16:17:52Z</dcterms:modified>
</cp:coreProperties>
</file>